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CC8645-2E2E-494F-9C20-9EFF9C9FAD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AB565-FE17-496A-96F1-5F61F5E208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086557-9FEF-4CD6-86E1-61827A74C6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DD1380-348A-4821-85CB-943A132DDA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E4BB2-E3EE-462F-8C0B-898DAB0949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80ABA-8576-4E89-9251-FFC0E9B06A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8D83CE-48C9-41DA-A0CA-72F3DA6115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ACEE4-5761-42B1-9B99-2157CA77FF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1C1A1-90E0-4044-8EBD-4E3D5D3990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89BE88-7930-48EC-898B-8B8597D85D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3F707-36EE-406C-92D7-264FA8BA2C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9EA18E-B692-4CC4-8A78-768EE7554E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A4D555-2229-4375-8B70-F5E561840EC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34800" y="269640"/>
            <a:ext cx="10825200" cy="5410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Calibri Light"/>
              </a:rPr>
              <a:t>FC27 and part of 3D7</a:t>
            </a:r>
            <a:br>
              <a:rPr sz="4000"/>
            </a:br>
            <a:endParaRPr b="0" lang="en-US" sz="4000" spc="-1" strike="noStrike">
              <a:solidFill>
                <a:srgbClr val="000000"/>
              </a:solidFill>
              <a:latin typeface="Calibri Light"/>
            </a:endParaRPr>
          </a:p>
        </p:txBody>
      </p:sp>
      <p:pic>
        <p:nvPicPr>
          <p:cNvPr id="42" name="Content Placeholder 5" descr=""/>
          <p:cNvPicPr/>
          <p:nvPr/>
        </p:nvPicPr>
        <p:blipFill>
          <a:blip r:embed="rId1"/>
          <a:stretch/>
        </p:blipFill>
        <p:spPr>
          <a:xfrm>
            <a:off x="158760" y="1287360"/>
            <a:ext cx="10312560" cy="4683240"/>
          </a:xfrm>
          <a:prstGeom prst="rect">
            <a:avLst/>
          </a:prstGeom>
          <a:ln w="0">
            <a:noFill/>
          </a:ln>
        </p:spPr>
      </p:pic>
      <p:sp>
        <p:nvSpPr>
          <p:cNvPr id="43" name="TextBox 8"/>
          <p:cNvSpPr/>
          <p:nvPr/>
        </p:nvSpPr>
        <p:spPr>
          <a:xfrm>
            <a:off x="2073240" y="1003320"/>
            <a:ext cx="811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    2     3     4    5   6   7     8    9      10       11  12  13   14  15    16  17   18 1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(2) Rest of 3D7; R033 and part of K1</a:t>
            </a:r>
            <a:br>
              <a:rPr sz="4400"/>
            </a:b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pic>
        <p:nvPicPr>
          <p:cNvPr id="45" name="Content Placeholder 3" descr=""/>
          <p:cNvPicPr/>
          <p:nvPr/>
        </p:nvPicPr>
        <p:blipFill>
          <a:blip r:embed="rId1"/>
          <a:srcRect l="2067" t="5936" r="6013" b="-5579"/>
          <a:stretch/>
        </p:blipFill>
        <p:spPr>
          <a:xfrm>
            <a:off x="1068480" y="1690560"/>
            <a:ext cx="7264440" cy="4349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(3) Rest of K1 and MAD20</a:t>
            </a:r>
            <a:br>
              <a:rPr sz="4400"/>
            </a:b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pic>
        <p:nvPicPr>
          <p:cNvPr id="47" name="Content Placeholder 3" descr=""/>
          <p:cNvPicPr/>
          <p:nvPr/>
        </p:nvPicPr>
        <p:blipFill>
          <a:blip r:embed="rId1"/>
          <a:stretch/>
        </p:blipFill>
        <p:spPr>
          <a:xfrm>
            <a:off x="515880" y="1825560"/>
            <a:ext cx="8261280" cy="4351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1081080" y="1982880"/>
          <a:ext cx="9813960" cy="3876480"/>
        </p:xfrm>
        <a:graphic>
          <a:graphicData uri="http://schemas.openxmlformats.org/drawingml/2006/table">
            <a:tbl>
              <a:tblPr/>
              <a:tblGrid>
                <a:gridCol w="4906800"/>
                <a:gridCol w="4907160"/>
              </a:tblGrid>
              <a:tr h="3236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ample ID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.OKM5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256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.0KM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.1KM5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22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.1KM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4.2KM5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36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.21KMO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5.3KM5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22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.28KM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6.7KM5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40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.0KM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.DD2 (a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22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.1KM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8.R03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40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.2KM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9.3D7 (a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22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.0KM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0.DD2 (b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40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9.21KM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1.3D7 (b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220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.0KM4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2.Wat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36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1.28KM4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spcAft>
                          <a:spcPts val="799"/>
                        </a:spcAft>
                        <a:tabLst>
                          <a:tab algn="l" pos="0"/>
                          <a:tab algn="l" pos="35784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"/>
          <p:cNvGraphicFramePr/>
          <p:nvPr/>
        </p:nvGraphicFramePr>
        <p:xfrm>
          <a:off x="1722600" y="1616040"/>
          <a:ext cx="6537240" cy="3949560"/>
        </p:xfrm>
        <a:graphic>
          <a:graphicData uri="http://schemas.openxmlformats.org/drawingml/2006/table">
            <a:tbl>
              <a:tblPr/>
              <a:tblGrid>
                <a:gridCol w="965160"/>
                <a:gridCol w="749160"/>
                <a:gridCol w="858960"/>
                <a:gridCol w="595080"/>
                <a:gridCol w="858960"/>
                <a:gridCol w="923760"/>
                <a:gridCol w="1586160"/>
              </a:tblGrid>
              <a:tr h="98748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63000" rIns="630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MSP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63000" rIns="630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MSP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New infection (N)/ Recrudescence (R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63000" rIns="630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K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MAD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RO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FC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 algn="ctr"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3D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0KM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K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FC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21KM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FC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3D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N/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28KM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K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FC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ff0000"/>
                          </a:solidFill>
                          <a:latin typeface="Calibri"/>
                          <a:ea typeface="Calibri"/>
                        </a:rPr>
                        <a:t>3D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0KM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K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FC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3D7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21KM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K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FC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3D7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4472c4"/>
                          </a:solidFill>
                          <a:latin typeface="Calibri"/>
                          <a:ea typeface="Calibri"/>
                        </a:rPr>
                        <a:t>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0KM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3D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21KM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3D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c45911"/>
                          </a:solidFill>
                          <a:latin typeface="Calibri"/>
                          <a:ea typeface="Calibri"/>
                        </a:rPr>
                        <a:t>N/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0KM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K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3D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28KM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K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3D7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Calibri"/>
                          <a:ea typeface="Calibri"/>
                        </a:rPr>
                        <a:t>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KM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K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FC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7KM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 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FC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3000" rIns="63000" tIns="0" bIns="0" anchor="t">
                      <a:noAutofit/>
                    </a:bodyPr>
                    <a:p>
                      <a:pPr>
                        <a:lnSpc>
                          <a:spcPct val="107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3000" marR="63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2-23T12:00:37Z</dcterms:created>
  <dc:creator>Microsoft account</dc:creator>
  <dc:description/>
  <dc:language>en-US</dc:language>
  <cp:lastModifiedBy>Anane Bernice Mawuli</cp:lastModifiedBy>
  <dcterms:modified xsi:type="dcterms:W3CDTF">2023-12-22T09:28:03Z</dcterms:modified>
  <cp:revision>11</cp:revision>
  <dc:subject/>
  <dc:title>FC27 and part of 3D7</dc:title>
</cp:coreProperties>
</file>